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75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246" y="90"/>
      </p:cViewPr>
      <p:guideLst>
        <p:guide orient="horz" pos="347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33641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7801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9435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38735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1915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97606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6948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4797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35256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0258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65648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8AD089-D445-47A7-9A9C-3DB0A4B2FA49}" type="datetimeFigureOut">
              <a:rPr lang="en-IN" smtClean="0"/>
              <a:t>28-12-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59F15-6276-47F2-92F6-FCB9574CC5A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3712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2879812" y="548680"/>
            <a:ext cx="3384376" cy="3686899"/>
            <a:chOff x="3419872" y="1686317"/>
            <a:chExt cx="3384376" cy="3686899"/>
          </a:xfrm>
        </p:grpSpPr>
        <p:grpSp>
          <p:nvGrpSpPr>
            <p:cNvPr id="4" name="Group 34"/>
            <p:cNvGrpSpPr>
              <a:grpSpLocks/>
            </p:cNvGrpSpPr>
            <p:nvPr/>
          </p:nvGrpSpPr>
          <p:grpSpPr bwMode="auto">
            <a:xfrm>
              <a:off x="3419872" y="1686317"/>
              <a:ext cx="3312368" cy="3686899"/>
              <a:chOff x="152400" y="3276600"/>
              <a:chExt cx="2057400" cy="2828925"/>
            </a:xfrm>
          </p:grpSpPr>
          <p:pic>
            <p:nvPicPr>
              <p:cNvPr id="5" name="Picture 5" descr="D:\Vivek\Gel pictrures\vivek\2010\1.2.10\gst pcr 1.2 &amp; 13.2.10\Untitled4.JPG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500" r="55833" b="51111"/>
              <a:stretch>
                <a:fillRect/>
              </a:stretch>
            </p:blipFill>
            <p:spPr bwMode="auto">
              <a:xfrm>
                <a:off x="152400" y="3276600"/>
                <a:ext cx="2057400" cy="2828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664179" y="4174308"/>
                <a:ext cx="229402" cy="454597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3 </a:t>
                </a:r>
                <a:r>
                  <a:rPr lang="en-US" sz="12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endParaRPr lang="en-US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1057523" y="4399495"/>
                <a:ext cx="229402" cy="395559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30 </a:t>
                </a:r>
                <a:r>
                  <a:rPr lang="en-US" sz="12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endParaRPr lang="en-US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440032" y="4635273"/>
                <a:ext cx="229402" cy="395559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9 </a:t>
                </a:r>
                <a:r>
                  <a:rPr lang="en-US" sz="12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endParaRPr lang="en-US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834885" y="4859044"/>
                <a:ext cx="229402" cy="395559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dirty="0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48 </a:t>
                </a:r>
                <a:r>
                  <a:rPr lang="en-US" sz="1200" dirty="0" err="1" smtClean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p</a:t>
                </a:r>
                <a:endParaRPr lang="en-US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" name="TextBox 9"/>
            <p:cNvSpPr txBox="1"/>
            <p:nvPr/>
          </p:nvSpPr>
          <p:spPr>
            <a:xfrm>
              <a:off x="3491880" y="1710433"/>
              <a:ext cx="33123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  M         GP1      GP2       GP3      GP4</a:t>
              </a:r>
              <a:endParaRPr lang="en-I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246121" y="4300836"/>
            <a:ext cx="6651757" cy="3527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S1 Fig. PCR </a:t>
            </a:r>
            <a:r>
              <a:rPr lang="en-US" sz="16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amplification of full length promoter and deletion fragments</a:t>
            </a:r>
            <a:r>
              <a:rPr lang="en-US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Mangal"/>
              </a:rPr>
              <a:t>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5420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2</TotalTime>
  <Words>27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angal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VEKANAND</dc:creator>
  <cp:lastModifiedBy>Avinash Mishra</cp:lastModifiedBy>
  <cp:revision>60</cp:revision>
  <dcterms:created xsi:type="dcterms:W3CDTF">2015-06-06T07:44:47Z</dcterms:created>
  <dcterms:modified xsi:type="dcterms:W3CDTF">2015-12-28T07:04:29Z</dcterms:modified>
</cp:coreProperties>
</file>